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5C4C7D-2D29-4D26-B5D9-5CD610CCD1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32A50-59A0-43F8-8935-027BD98527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27E3C-1132-4A0B-A94B-C25F52CB4B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BA42EF-AD74-4E23-8FAC-1AD5BD96D0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37D8F-3829-4F8C-A14B-E3424221E6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AE7967-DD38-4789-B261-414AEF57AC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DA2402-B0E2-4B32-8038-AE07C41C6C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DC29A-DF1F-4F89-BBA3-B839FEBC37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DA16B-F503-4F89-B1E8-7A1243BEDF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83C46F-4CF8-4C53-9CFA-FCCB2C44C8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E62DBE-A0CD-4B93-8B9E-6480ED3A8E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6F2A5-B5DB-4F50-B15D-43572209AE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263DCC-748C-40F1-90B9-A5866EEE7AA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826920" y="1089000"/>
            <a:ext cx="7200360" cy="4500000"/>
            <a:chOff x="826920" y="1089000"/>
            <a:chExt cx="7200360" cy="4500000"/>
          </a:xfrm>
        </p:grpSpPr>
        <p:sp>
          <p:nvSpPr>
            <p:cNvPr id="42" name=""/>
            <p:cNvSpPr/>
            <p:nvPr/>
          </p:nvSpPr>
          <p:spPr>
            <a:xfrm>
              <a:off x="826920" y="4421160"/>
              <a:ext cx="4464360" cy="216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1055520" y="2454120"/>
              <a:ext cx="507600" cy="2418480"/>
              <a:chOff x="1055520" y="2454120"/>
              <a:chExt cx="507600" cy="2418480"/>
            </a:xfrm>
          </p:grpSpPr>
          <p:sp>
            <p:nvSpPr>
              <p:cNvPr id="44" name=""/>
              <p:cNvSpPr/>
              <p:nvPr/>
            </p:nvSpPr>
            <p:spPr>
              <a:xfrm>
                <a:off x="1183680" y="319392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1183680" y="362412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5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1183680" y="405900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3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1183680" y="456552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1085040" y="291132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055520" y="2454120"/>
                <a:ext cx="506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400" spc="-1" strike="noStrike">
                    <a:solidFill>
                      <a:srgbClr val="000000"/>
                    </a:solidFill>
                    <a:latin typeface="Arial"/>
                  </a:rPr>
                  <a:t>kD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50" name="" descr=""/>
            <p:cNvPicPr/>
            <p:nvPr/>
          </p:nvPicPr>
          <p:blipFill>
            <a:blip r:embed="rId1"/>
            <a:stretch/>
          </p:blipFill>
          <p:spPr>
            <a:xfrm>
              <a:off x="1890720" y="2476440"/>
              <a:ext cx="1690560" cy="2521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" descr=""/>
            <p:cNvPicPr/>
            <p:nvPr/>
          </p:nvPicPr>
          <p:blipFill>
            <a:blip r:embed="rId2"/>
            <a:stretch/>
          </p:blipFill>
          <p:spPr>
            <a:xfrm>
              <a:off x="1601640" y="2478240"/>
              <a:ext cx="187560" cy="251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" descr=""/>
            <p:cNvPicPr/>
            <p:nvPr/>
          </p:nvPicPr>
          <p:blipFill>
            <a:blip r:embed="rId3"/>
            <a:stretch/>
          </p:blipFill>
          <p:spPr>
            <a:xfrm>
              <a:off x="7351560" y="2460600"/>
              <a:ext cx="227160" cy="2536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" descr=""/>
            <p:cNvPicPr/>
            <p:nvPr/>
          </p:nvPicPr>
          <p:blipFill>
            <a:blip r:embed="rId4"/>
            <a:stretch/>
          </p:blipFill>
          <p:spPr>
            <a:xfrm>
              <a:off x="5562720" y="2478240"/>
              <a:ext cx="1712880" cy="251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" descr=""/>
            <p:cNvPicPr/>
            <p:nvPr/>
          </p:nvPicPr>
          <p:blipFill>
            <a:blip r:embed="rId5"/>
            <a:stretch/>
          </p:blipFill>
          <p:spPr>
            <a:xfrm>
              <a:off x="3691080" y="2476440"/>
              <a:ext cx="1760400" cy="25210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5" name=""/>
            <p:cNvGrpSpPr/>
            <p:nvPr/>
          </p:nvGrpSpPr>
          <p:grpSpPr>
            <a:xfrm>
              <a:off x="7519680" y="2476440"/>
              <a:ext cx="507600" cy="2418480"/>
              <a:chOff x="7519680" y="2476440"/>
              <a:chExt cx="507600" cy="2418480"/>
            </a:xfrm>
          </p:grpSpPr>
          <p:sp>
            <p:nvSpPr>
              <p:cNvPr id="56" name=""/>
              <p:cNvSpPr/>
              <p:nvPr/>
            </p:nvSpPr>
            <p:spPr>
              <a:xfrm>
                <a:off x="7647840" y="321624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7647840" y="364644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5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7647840" y="408132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3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7647840" y="458784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7549200" y="293364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7519680" y="2476440"/>
                <a:ext cx="5068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400" spc="-1" strike="noStrike">
                    <a:solidFill>
                      <a:srgbClr val="000000"/>
                    </a:solidFill>
                    <a:latin typeface="Arial"/>
                  </a:rPr>
                  <a:t>kD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2" name=""/>
            <p:cNvSpPr/>
            <p:nvPr/>
          </p:nvSpPr>
          <p:spPr>
            <a:xfrm>
              <a:off x="2123640" y="5068800"/>
              <a:ext cx="10616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JFC 12T1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(30 sec.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211640" y="5068800"/>
              <a:ext cx="7354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US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(3 min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794920" y="5068800"/>
              <a:ext cx="13406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</a:rPr>
                <a:t>SigmaPrestig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</a:rPr>
                <a:t>(5 min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5" name=""/>
            <p:cNvGrpSpPr/>
            <p:nvPr/>
          </p:nvGrpSpPr>
          <p:grpSpPr>
            <a:xfrm>
              <a:off x="1890720" y="1089000"/>
              <a:ext cx="1640160" cy="1369800"/>
              <a:chOff x="1890720" y="1089000"/>
              <a:chExt cx="1640160" cy="1369800"/>
            </a:xfrm>
          </p:grpSpPr>
          <p:sp>
            <p:nvSpPr>
              <p:cNvPr id="66" name=""/>
              <p:cNvSpPr/>
              <p:nvPr/>
            </p:nvSpPr>
            <p:spPr>
              <a:xfrm rot="16200000">
                <a:off x="1344960" y="1634760"/>
                <a:ext cx="1368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EK 293-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 rot="16200000">
                <a:off x="1706040" y="1657800"/>
                <a:ext cx="1325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EK 293-TKTL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rot="16200000">
                <a:off x="2467080" y="2076840"/>
                <a:ext cx="485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JA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 rot="16200000">
                <a:off x="2748240" y="2015280"/>
                <a:ext cx="605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el2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rot="16200000">
                <a:off x="3119400" y="2045520"/>
                <a:ext cx="546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U25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" name=""/>
            <p:cNvGrpSpPr/>
            <p:nvPr/>
          </p:nvGrpSpPr>
          <p:grpSpPr>
            <a:xfrm>
              <a:off x="3797280" y="1089000"/>
              <a:ext cx="1640160" cy="1369800"/>
              <a:chOff x="3797280" y="1089000"/>
              <a:chExt cx="1640160" cy="1369800"/>
            </a:xfrm>
          </p:grpSpPr>
          <p:sp>
            <p:nvSpPr>
              <p:cNvPr id="72" name=""/>
              <p:cNvSpPr/>
              <p:nvPr/>
            </p:nvSpPr>
            <p:spPr>
              <a:xfrm rot="16200000">
                <a:off x="3251520" y="1634760"/>
                <a:ext cx="1368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EK 293-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rot="16200000">
                <a:off x="3612600" y="1657800"/>
                <a:ext cx="1325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EK 293-TKTL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 rot="16200000">
                <a:off x="4373640" y="2076840"/>
                <a:ext cx="485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JA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 rot="16200000">
                <a:off x="4654800" y="2015280"/>
                <a:ext cx="605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el2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rot="16200000">
                <a:off x="5025960" y="2045520"/>
                <a:ext cx="546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U25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7" name=""/>
            <p:cNvGrpSpPr/>
            <p:nvPr/>
          </p:nvGrpSpPr>
          <p:grpSpPr>
            <a:xfrm>
              <a:off x="5580000" y="1089000"/>
              <a:ext cx="1640160" cy="1369800"/>
              <a:chOff x="5580000" y="1089000"/>
              <a:chExt cx="1640160" cy="1369800"/>
            </a:xfrm>
          </p:grpSpPr>
          <p:sp>
            <p:nvSpPr>
              <p:cNvPr id="78" name=""/>
              <p:cNvSpPr/>
              <p:nvPr/>
            </p:nvSpPr>
            <p:spPr>
              <a:xfrm rot="16200000">
                <a:off x="5034240" y="1634760"/>
                <a:ext cx="1368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EK 293-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rot="16200000">
                <a:off x="5395320" y="1657800"/>
                <a:ext cx="1325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EK 293-TKTL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rot="16200000">
                <a:off x="6156360" y="2076840"/>
                <a:ext cx="485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JA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rot="16200000">
                <a:off x="6437520" y="2015280"/>
                <a:ext cx="605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Mel2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rot="16200000">
                <a:off x="6808680" y="2045520"/>
                <a:ext cx="5464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U25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83" name=""/>
          <p:cNvSpPr/>
          <p:nvPr/>
        </p:nvSpPr>
        <p:spPr>
          <a:xfrm>
            <a:off x="155520" y="177840"/>
            <a:ext cx="3943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1400" spc="-1" strike="noStrike">
                <a:solidFill>
                  <a:srgbClr val="000000"/>
                </a:solidFill>
                <a:latin typeface="Arial"/>
              </a:rPr>
              <a:t>Supplemental figure 1, Kämmerer U et al. revi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06T12:03:12Z</dcterms:created>
  <dc:creator>Kaemmerer_U</dc:creator>
  <dc:description/>
  <dc:language>en-US</dc:language>
  <cp:lastModifiedBy>Kaemmerer_U</cp:lastModifiedBy>
  <dcterms:modified xsi:type="dcterms:W3CDTF">2014-11-04T15:32:02Z</dcterms:modified>
  <cp:revision>13</cp:revision>
  <dc:subject/>
  <dc:title>Folie 1</dc:title>
</cp:coreProperties>
</file>